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4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6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01E3D37-C8C5-4E1E-BB80-D0C68E46093A}"/>
              </a:ext>
            </a:extLst>
          </p:cNvPr>
          <p:cNvSpPr/>
          <p:nvPr/>
        </p:nvSpPr>
        <p:spPr>
          <a:xfrm>
            <a:off x="467144" y="1344915"/>
            <a:ext cx="5923709" cy="24711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0CDE3B4E-C87B-41E7-AE99-E594B805750A}"/>
              </a:ext>
            </a:extLst>
          </p:cNvPr>
          <p:cNvGrpSpPr/>
          <p:nvPr/>
        </p:nvGrpSpPr>
        <p:grpSpPr>
          <a:xfrm>
            <a:off x="1025565" y="1850052"/>
            <a:ext cx="4415755" cy="554080"/>
            <a:chOff x="1025565" y="1850052"/>
            <a:chExt cx="4415755" cy="554080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F2A197E6-595D-467A-A3C9-080C01B61B3C}"/>
                </a:ext>
              </a:extLst>
            </p:cNvPr>
            <p:cNvGrpSpPr/>
            <p:nvPr/>
          </p:nvGrpSpPr>
          <p:grpSpPr>
            <a:xfrm>
              <a:off x="1025565" y="1990095"/>
              <a:ext cx="4415755" cy="261610"/>
              <a:chOff x="1025565" y="1990095"/>
              <a:chExt cx="4415755" cy="261610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C005812F-E14D-47D1-B62D-922DEBE144C8}"/>
                  </a:ext>
                </a:extLst>
              </p:cNvPr>
              <p:cNvGrpSpPr/>
              <p:nvPr/>
            </p:nvGrpSpPr>
            <p:grpSpPr>
              <a:xfrm>
                <a:off x="1025565" y="1990095"/>
                <a:ext cx="4415755" cy="261610"/>
                <a:chOff x="598205" y="1022355"/>
                <a:chExt cx="4415755" cy="261610"/>
              </a:xfrm>
            </p:grpSpPr>
            <p:cxnSp>
              <p:nvCxnSpPr>
                <p:cNvPr id="6" name="Straight Connector 5">
                  <a:extLst>
                    <a:ext uri="{FF2B5EF4-FFF2-40B4-BE49-F238E27FC236}">
                      <a16:creationId xmlns:a16="http://schemas.microsoft.com/office/drawing/2014/main" id="{D6EF0102-26BC-4E88-A961-2DE03C4BF183}"/>
                    </a:ext>
                  </a:extLst>
                </p:cNvPr>
                <p:cNvCxnSpPr/>
                <p:nvPr/>
              </p:nvCxnSpPr>
              <p:spPr>
                <a:xfrm>
                  <a:off x="1513840" y="1153160"/>
                  <a:ext cx="3500120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724AA862-D84F-4350-A662-15FDB2B6A3DE}"/>
                    </a:ext>
                  </a:extLst>
                </p:cNvPr>
                <p:cNvSpPr txBox="1"/>
                <p:nvPr/>
              </p:nvSpPr>
              <p:spPr>
                <a:xfrm>
                  <a:off x="598205" y="1022355"/>
                  <a:ext cx="87876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KK2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ene</a:t>
                  </a:r>
                </a:p>
              </p:txBody>
            </p:sp>
          </p:grp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74369274-31AD-42C8-9D26-9986A2D54227}"/>
                  </a:ext>
                </a:extLst>
              </p:cNvPr>
              <p:cNvSpPr/>
              <p:nvPr/>
            </p:nvSpPr>
            <p:spPr>
              <a:xfrm>
                <a:off x="2251710" y="2079633"/>
                <a:ext cx="929640" cy="82534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' homology arm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EBF6E16-55BA-4686-8AAB-192CEC660171}"/>
                  </a:ext>
                </a:extLst>
              </p:cNvPr>
              <p:cNvSpPr/>
              <p:nvPr/>
            </p:nvSpPr>
            <p:spPr>
              <a:xfrm>
                <a:off x="4067140" y="2079633"/>
                <a:ext cx="929640" cy="82534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' homology arm</a:t>
                </a:r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53354381-E2AF-41E6-BF5B-9FD627546152}"/>
                  </a:ext>
                </a:extLst>
              </p:cNvPr>
              <p:cNvSpPr/>
              <p:nvPr/>
            </p:nvSpPr>
            <p:spPr>
              <a:xfrm>
                <a:off x="3377565" y="2079633"/>
                <a:ext cx="501421" cy="82534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 err="1">
                    <a:solidFill>
                      <a:schemeClr val="tx1"/>
                    </a:solidFill>
                    <a:highlight>
                      <a:srgbClr val="FFFF00"/>
                    </a:highligh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leoR</a:t>
                </a:r>
                <a:endParaRPr lang="en-US" sz="600" b="1" dirty="0">
                  <a:solidFill>
                    <a:schemeClr val="tx1"/>
                  </a:solidFill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F6DCDFC6-78DD-4069-A9F4-E6FED0FF1D0C}"/>
                  </a:ext>
                </a:extLst>
              </p:cNvPr>
              <p:cNvSpPr/>
              <p:nvPr/>
            </p:nvSpPr>
            <p:spPr>
              <a:xfrm>
                <a:off x="3285274" y="2079633"/>
                <a:ext cx="68986" cy="82534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BCD8E83C-CE48-4F36-A764-C1ED922D88E3}"/>
                  </a:ext>
                </a:extLst>
              </p:cNvPr>
              <p:cNvSpPr/>
              <p:nvPr/>
            </p:nvSpPr>
            <p:spPr>
              <a:xfrm>
                <a:off x="3198292" y="2079633"/>
                <a:ext cx="68986" cy="82534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DFE02DCE-2F6F-4E11-B103-F86FB36318C1}"/>
                  </a:ext>
                </a:extLst>
              </p:cNvPr>
              <p:cNvSpPr/>
              <p:nvPr/>
            </p:nvSpPr>
            <p:spPr>
              <a:xfrm>
                <a:off x="3979424" y="2079633"/>
                <a:ext cx="68986" cy="82534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5CE33316-8480-4247-82B5-6228DE3B98FC}"/>
                  </a:ext>
                </a:extLst>
              </p:cNvPr>
              <p:cNvSpPr/>
              <p:nvPr/>
            </p:nvSpPr>
            <p:spPr>
              <a:xfrm>
                <a:off x="3896252" y="2079633"/>
                <a:ext cx="68986" cy="82534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C37CD245-FEA9-41DE-937F-251482A77C3F}"/>
                </a:ext>
              </a:extLst>
            </p:cNvPr>
            <p:cNvGrpSpPr/>
            <p:nvPr/>
          </p:nvGrpSpPr>
          <p:grpSpPr>
            <a:xfrm>
              <a:off x="3064660" y="1850052"/>
              <a:ext cx="466297" cy="386330"/>
              <a:chOff x="3032795" y="1727962"/>
              <a:chExt cx="466297" cy="486378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A3E24095-C5FC-42DE-92FE-2D37234AB236}"/>
                  </a:ext>
                </a:extLst>
              </p:cNvPr>
              <p:cNvGrpSpPr/>
              <p:nvPr/>
            </p:nvGrpSpPr>
            <p:grpSpPr>
              <a:xfrm>
                <a:off x="3032795" y="1822273"/>
                <a:ext cx="441228" cy="107026"/>
                <a:chOff x="2950633" y="1681769"/>
                <a:chExt cx="447887" cy="107026"/>
              </a:xfrm>
            </p:grpSpPr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0A14BB81-D01C-42E3-B2CF-696B2E14FE3E}"/>
                    </a:ext>
                  </a:extLst>
                </p:cNvPr>
                <p:cNvCxnSpPr/>
                <p:nvPr/>
              </p:nvCxnSpPr>
              <p:spPr>
                <a:xfrm>
                  <a:off x="2964180" y="1788795"/>
                  <a:ext cx="434340" cy="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32" name="Group 31">
                  <a:extLst>
                    <a:ext uri="{FF2B5EF4-FFF2-40B4-BE49-F238E27FC236}">
                      <a16:creationId xmlns:a16="http://schemas.microsoft.com/office/drawing/2014/main" id="{686A6EB5-E3F7-476A-98F5-81FFAC6C4C42}"/>
                    </a:ext>
                  </a:extLst>
                </p:cNvPr>
                <p:cNvGrpSpPr/>
                <p:nvPr/>
              </p:nvGrpSpPr>
              <p:grpSpPr>
                <a:xfrm>
                  <a:off x="2950633" y="1681769"/>
                  <a:ext cx="45719" cy="101611"/>
                  <a:chOff x="2739178" y="1614794"/>
                  <a:chExt cx="45719" cy="101611"/>
                </a:xfrm>
              </p:grpSpPr>
              <p:cxnSp>
                <p:nvCxnSpPr>
                  <p:cNvPr id="29" name="Straight Connector 28">
                    <a:extLst>
                      <a:ext uri="{FF2B5EF4-FFF2-40B4-BE49-F238E27FC236}">
                        <a16:creationId xmlns:a16="http://schemas.microsoft.com/office/drawing/2014/main" id="{8E28D8F4-7F81-4185-9C89-89513D59C30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762038" y="1664970"/>
                    <a:ext cx="0" cy="51435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" name="Flowchart: Connector 29">
                    <a:extLst>
                      <a:ext uri="{FF2B5EF4-FFF2-40B4-BE49-F238E27FC236}">
                        <a16:creationId xmlns:a16="http://schemas.microsoft.com/office/drawing/2014/main" id="{8F9F2298-BC5D-4592-9212-59DB9A49DC23}"/>
                      </a:ext>
                    </a:extLst>
                  </p:cNvPr>
                  <p:cNvSpPr/>
                  <p:nvPr/>
                </p:nvSpPr>
                <p:spPr>
                  <a:xfrm>
                    <a:off x="2739178" y="1614794"/>
                    <a:ext cx="45719" cy="45719"/>
                  </a:xfrm>
                  <a:prstGeom prst="flowChartConnector">
                    <a:avLst/>
                  </a:prstGeom>
                  <a:scene3d>
                    <a:camera prst="orthographicFront"/>
                    <a:lightRig rig="threePt" dir="t"/>
                  </a:scene3d>
                  <a:sp3d>
                    <a:bevelT/>
                    <a:bevelB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C2262D3-6179-4BC5-9E7C-1B8412B65698}"/>
                  </a:ext>
                </a:extLst>
              </p:cNvPr>
              <p:cNvSpPr txBox="1"/>
              <p:nvPr/>
            </p:nvSpPr>
            <p:spPr>
              <a:xfrm>
                <a:off x="3062802" y="1727962"/>
                <a:ext cx="434521" cy="2518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M2</a:t>
                </a:r>
                <a:endPara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3CD5FA95-A465-473D-9861-4E7A568125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D3D3D3"/>
                  </a:clrFrom>
                  <a:clrTo>
                    <a:srgbClr val="D3D3D3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32795" y="1750811"/>
                <a:ext cx="150770" cy="48206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9697A26C-016F-4A6B-A755-2AF13AC7C7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3348322" y="2166134"/>
                <a:ext cx="150770" cy="48206"/>
              </a:xfrm>
              <a:prstGeom prst="rect">
                <a:avLst/>
              </a:prstGeom>
            </p:spPr>
          </p:pic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994A1D40-1C95-4CF6-A9E8-85EC56D6F292}"/>
                </a:ext>
              </a:extLst>
            </p:cNvPr>
            <p:cNvGrpSpPr/>
            <p:nvPr/>
          </p:nvGrpSpPr>
          <p:grpSpPr>
            <a:xfrm>
              <a:off x="3741451" y="1988251"/>
              <a:ext cx="461473" cy="415881"/>
              <a:chOff x="3774679" y="2045782"/>
              <a:chExt cx="461473" cy="415881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C2808E87-9D09-4ED8-92D1-66719C7B0ECE}"/>
                  </a:ext>
                </a:extLst>
              </p:cNvPr>
              <p:cNvGrpSpPr/>
              <p:nvPr/>
            </p:nvGrpSpPr>
            <p:grpSpPr>
              <a:xfrm>
                <a:off x="3791682" y="2284725"/>
                <a:ext cx="444470" cy="101611"/>
                <a:chOff x="3837929" y="2304767"/>
                <a:chExt cx="444470" cy="101611"/>
              </a:xfrm>
            </p:grpSpPr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id="{523EC54F-D5AE-436C-89B1-5D135CD7E7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0800000" flipH="1">
                  <a:off x="3837929" y="2309931"/>
                  <a:ext cx="428581" cy="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5C748BA3-39EE-491F-89F4-616201707F24}"/>
                    </a:ext>
                  </a:extLst>
                </p:cNvPr>
                <p:cNvGrpSpPr/>
                <p:nvPr/>
              </p:nvGrpSpPr>
              <p:grpSpPr>
                <a:xfrm rot="10800000" flipH="1">
                  <a:off x="4237286" y="2304767"/>
                  <a:ext cx="45113" cy="101611"/>
                  <a:chOff x="2739178" y="1614794"/>
                  <a:chExt cx="45719" cy="101611"/>
                </a:xfrm>
              </p:grpSpPr>
              <p:cxnSp>
                <p:nvCxnSpPr>
                  <p:cNvPr id="42" name="Straight Connector 41">
                    <a:extLst>
                      <a:ext uri="{FF2B5EF4-FFF2-40B4-BE49-F238E27FC236}">
                        <a16:creationId xmlns:a16="http://schemas.microsoft.com/office/drawing/2014/main" id="{908663B5-403E-4C99-9B0B-DFAD53EC3C5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762038" y="1664970"/>
                    <a:ext cx="0" cy="51435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3" name="Flowchart: Connector 42">
                    <a:extLst>
                      <a:ext uri="{FF2B5EF4-FFF2-40B4-BE49-F238E27FC236}">
                        <a16:creationId xmlns:a16="http://schemas.microsoft.com/office/drawing/2014/main" id="{0C53BFE2-B143-4A63-AC79-A0A53B3824CA}"/>
                      </a:ext>
                    </a:extLst>
                  </p:cNvPr>
                  <p:cNvSpPr/>
                  <p:nvPr/>
                </p:nvSpPr>
                <p:spPr>
                  <a:xfrm>
                    <a:off x="2739178" y="1614794"/>
                    <a:ext cx="45719" cy="45719"/>
                  </a:xfrm>
                  <a:prstGeom prst="flowChartConnector">
                    <a:avLst/>
                  </a:prstGeom>
                  <a:scene3d>
                    <a:camera prst="orthographicFront"/>
                    <a:lightRig rig="threePt" dir="t"/>
                  </a:scene3d>
                  <a:sp3d>
                    <a:bevelT/>
                    <a:bevelB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D9FC9C80-0114-4E11-BD40-C3DACB5120CF}"/>
                  </a:ext>
                </a:extLst>
              </p:cNvPr>
              <p:cNvSpPr txBox="1"/>
              <p:nvPr/>
            </p:nvSpPr>
            <p:spPr>
              <a:xfrm>
                <a:off x="3774679" y="2258384"/>
                <a:ext cx="43225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M1</a:t>
                </a:r>
                <a:endPara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15074919-A011-48E1-93E0-464CBEC33A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D3D3D3"/>
                  </a:clrFrom>
                  <a:clrTo>
                    <a:srgbClr val="D3D3D3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74679" y="2045782"/>
                <a:ext cx="150770" cy="48206"/>
              </a:xfrm>
              <a:prstGeom prst="rect">
                <a:avLst/>
              </a:prstGeom>
            </p:spPr>
          </p:pic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88A9AB07-3267-430E-A0AD-E6A2247C5C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4072505" y="2413457"/>
                <a:ext cx="150770" cy="48206"/>
              </a:xfrm>
              <a:prstGeom prst="rect">
                <a:avLst/>
              </a:prstGeom>
            </p:spPr>
          </p:pic>
        </p:grp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6C2AA7BC-3923-42EA-B08D-79FC5C7CEB2B}"/>
              </a:ext>
            </a:extLst>
          </p:cNvPr>
          <p:cNvGrpSpPr/>
          <p:nvPr/>
        </p:nvGrpSpPr>
        <p:grpSpPr>
          <a:xfrm>
            <a:off x="1036365" y="2773440"/>
            <a:ext cx="4415755" cy="376175"/>
            <a:chOff x="1036365" y="2773440"/>
            <a:chExt cx="4415755" cy="376175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695AE489-B4AA-41FA-83FE-7629413E2601}"/>
                </a:ext>
              </a:extLst>
            </p:cNvPr>
            <p:cNvGrpSpPr/>
            <p:nvPr/>
          </p:nvGrpSpPr>
          <p:grpSpPr>
            <a:xfrm>
              <a:off x="1036365" y="2888005"/>
              <a:ext cx="4415755" cy="261610"/>
              <a:chOff x="1036365" y="2888005"/>
              <a:chExt cx="4415755" cy="261610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19E2BB8A-D938-4AB4-829C-FE3C3F497C5C}"/>
                  </a:ext>
                </a:extLst>
              </p:cNvPr>
              <p:cNvGrpSpPr/>
              <p:nvPr/>
            </p:nvGrpSpPr>
            <p:grpSpPr>
              <a:xfrm>
                <a:off x="1036365" y="2888005"/>
                <a:ext cx="4415755" cy="261610"/>
                <a:chOff x="598205" y="1992003"/>
                <a:chExt cx="4415755" cy="261610"/>
              </a:xfrm>
            </p:grpSpPr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id="{2F58BCB6-6269-4E24-9048-17D290B960EE}"/>
                    </a:ext>
                  </a:extLst>
                </p:cNvPr>
                <p:cNvCxnSpPr/>
                <p:nvPr/>
              </p:nvCxnSpPr>
              <p:spPr>
                <a:xfrm>
                  <a:off x="1513840" y="2133600"/>
                  <a:ext cx="3500120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49D3BC3-D436-4E6D-AAFF-B38603C673FA}"/>
                    </a:ext>
                  </a:extLst>
                </p:cNvPr>
                <p:cNvSpPr txBox="1"/>
                <p:nvPr/>
              </p:nvSpPr>
              <p:spPr>
                <a:xfrm>
                  <a:off x="598205" y="1992003"/>
                  <a:ext cx="85472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β</a:t>
                  </a:r>
                  <a:r>
                    <a:rPr lang="en-US" sz="11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r>
                    <a:rPr lang="en-US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ene</a:t>
                  </a:r>
                </a:p>
              </p:txBody>
            </p:sp>
          </p:grp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0960FBE1-4BCD-41C4-B1FB-D3B0AA196EBC}"/>
                  </a:ext>
                </a:extLst>
              </p:cNvPr>
              <p:cNvSpPr/>
              <p:nvPr/>
            </p:nvSpPr>
            <p:spPr>
              <a:xfrm>
                <a:off x="3050632" y="2992160"/>
                <a:ext cx="1048927" cy="82467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BC2C4545-62BD-473D-A962-1126E34BF95F}"/>
                  </a:ext>
                </a:extLst>
              </p:cNvPr>
              <p:cNvSpPr/>
              <p:nvPr/>
            </p:nvSpPr>
            <p:spPr>
              <a:xfrm>
                <a:off x="4766613" y="2996623"/>
                <a:ext cx="113568" cy="74882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2D9ACD9F-76D8-493E-A1E6-128CE454630B}"/>
                  </a:ext>
                </a:extLst>
              </p:cNvPr>
              <p:cNvSpPr/>
              <p:nvPr/>
            </p:nvSpPr>
            <p:spPr>
              <a:xfrm>
                <a:off x="4248039" y="2992161"/>
                <a:ext cx="334548" cy="74882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8537C732-887B-42D5-9134-23B69980160E}"/>
                  </a:ext>
                </a:extLst>
              </p:cNvPr>
              <p:cNvSpPr/>
              <p:nvPr/>
            </p:nvSpPr>
            <p:spPr>
              <a:xfrm>
                <a:off x="2762038" y="2992161"/>
                <a:ext cx="113568" cy="74882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D04FFFB4-2422-48E8-B81C-0D8CAF357E5C}"/>
                </a:ext>
              </a:extLst>
            </p:cNvPr>
            <p:cNvGrpSpPr/>
            <p:nvPr/>
          </p:nvGrpSpPr>
          <p:grpSpPr>
            <a:xfrm>
              <a:off x="3460338" y="2773440"/>
              <a:ext cx="450612" cy="370359"/>
              <a:chOff x="3453399" y="2581130"/>
              <a:chExt cx="450612" cy="370359"/>
            </a:xfrm>
          </p:grpSpPr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9640F6D7-A361-4401-9F6D-2F7778A7AD4E}"/>
                  </a:ext>
                </a:extLst>
              </p:cNvPr>
              <p:cNvGrpSpPr/>
              <p:nvPr/>
            </p:nvGrpSpPr>
            <p:grpSpPr>
              <a:xfrm>
                <a:off x="3462783" y="2654457"/>
                <a:ext cx="441228" cy="107026"/>
                <a:chOff x="2950633" y="1681769"/>
                <a:chExt cx="447887" cy="107026"/>
              </a:xfrm>
            </p:grpSpPr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87A4D1FB-896E-452E-B801-A2A27F99F0BF}"/>
                    </a:ext>
                  </a:extLst>
                </p:cNvPr>
                <p:cNvCxnSpPr/>
                <p:nvPr/>
              </p:nvCxnSpPr>
              <p:spPr>
                <a:xfrm>
                  <a:off x="2964180" y="1788795"/>
                  <a:ext cx="434340" cy="0"/>
                </a:xfrm>
                <a:prstGeom prst="line">
                  <a:avLst/>
                </a:prstGeom>
                <a:ln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8" name="Group 47">
                  <a:extLst>
                    <a:ext uri="{FF2B5EF4-FFF2-40B4-BE49-F238E27FC236}">
                      <a16:creationId xmlns:a16="http://schemas.microsoft.com/office/drawing/2014/main" id="{86AEF26C-098E-4954-9B74-6F698132FC20}"/>
                    </a:ext>
                  </a:extLst>
                </p:cNvPr>
                <p:cNvGrpSpPr/>
                <p:nvPr/>
              </p:nvGrpSpPr>
              <p:grpSpPr>
                <a:xfrm>
                  <a:off x="2950633" y="1681769"/>
                  <a:ext cx="45719" cy="101611"/>
                  <a:chOff x="2739178" y="1614794"/>
                  <a:chExt cx="45719" cy="101611"/>
                </a:xfrm>
              </p:grpSpPr>
              <p:cxnSp>
                <p:nvCxnSpPr>
                  <p:cNvPr id="49" name="Straight Connector 48">
                    <a:extLst>
                      <a:ext uri="{FF2B5EF4-FFF2-40B4-BE49-F238E27FC236}">
                        <a16:creationId xmlns:a16="http://schemas.microsoft.com/office/drawing/2014/main" id="{22565216-63C2-4FD0-A651-8DE2376D0C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762038" y="1664970"/>
                    <a:ext cx="0" cy="51435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0" name="Flowchart: Connector 49">
                    <a:extLst>
                      <a:ext uri="{FF2B5EF4-FFF2-40B4-BE49-F238E27FC236}">
                        <a16:creationId xmlns:a16="http://schemas.microsoft.com/office/drawing/2014/main" id="{942FF8E7-88C3-4F26-8F4B-0C2DC3417A1D}"/>
                      </a:ext>
                    </a:extLst>
                  </p:cNvPr>
                  <p:cNvSpPr/>
                  <p:nvPr/>
                </p:nvSpPr>
                <p:spPr>
                  <a:xfrm>
                    <a:off x="2739178" y="1614794"/>
                    <a:ext cx="45719" cy="45719"/>
                  </a:xfrm>
                  <a:prstGeom prst="flowChartConnector">
                    <a:avLst/>
                  </a:prstGeom>
                  <a:scene3d>
                    <a:camera prst="orthographicFront"/>
                    <a:lightRig rig="threePt" dir="t"/>
                  </a:scene3d>
                  <a:sp3d>
                    <a:bevelT/>
                    <a:bevelB/>
                  </a:sp3d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CD4F0C09-0F2E-4A1B-B911-FD89D5306F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D3D3D3"/>
                  </a:clrFrom>
                  <a:clrTo>
                    <a:srgbClr val="D3D3D3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53399" y="2581130"/>
                <a:ext cx="150770" cy="48206"/>
              </a:xfrm>
              <a:prstGeom prst="rect">
                <a:avLst/>
              </a:prstGeom>
            </p:spPr>
          </p:pic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A4673B09-F38A-41C1-8596-286D7D52F8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3753241" y="2903283"/>
                <a:ext cx="150770" cy="48206"/>
              </a:xfrm>
              <a:prstGeom prst="rect">
                <a:avLst/>
              </a:prstGeom>
            </p:spPr>
          </p:pic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C739D6AC-A2B4-471F-B060-6E44BB1C9DF3}"/>
                  </a:ext>
                </a:extLst>
              </p:cNvPr>
              <p:cNvSpPr txBox="1"/>
              <p:nvPr/>
            </p:nvSpPr>
            <p:spPr>
              <a:xfrm>
                <a:off x="3485302" y="2592021"/>
                <a:ext cx="3999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C</a:t>
                </a:r>
                <a:endParaRPr 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76" name="TextBox 75">
            <a:extLst>
              <a:ext uri="{FF2B5EF4-FFF2-40B4-BE49-F238E27FC236}">
                <a16:creationId xmlns:a16="http://schemas.microsoft.com/office/drawing/2014/main" id="{9BDE48FC-DA2F-43A9-93F2-D926B13074DE}"/>
              </a:ext>
            </a:extLst>
          </p:cNvPr>
          <p:cNvSpPr txBox="1"/>
          <p:nvPr/>
        </p:nvSpPr>
        <p:spPr>
          <a:xfrm>
            <a:off x="682752" y="4070391"/>
            <a:ext cx="5480304" cy="46166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cs typeface="Times New Roman" panose="02020603050405020304" pitchFamily="18" charset="0"/>
              </a:rPr>
              <a:t>Supplementary Figure 22 | </a:t>
            </a:r>
            <a:r>
              <a:rPr lang="en-US" sz="1200" dirty="0">
                <a:cs typeface="Times New Roman" panose="02020603050405020304" pitchFamily="18" charset="0"/>
              </a:rPr>
              <a:t>Schematic of TaqMan real-time PCR FAM and VIC target assays in this study. Yellow rectangles exhibited CDS.</a:t>
            </a:r>
          </a:p>
        </p:txBody>
      </p:sp>
    </p:spTree>
    <p:extLst>
      <p:ext uri="{BB962C8B-B14F-4D97-AF65-F5344CB8AC3E}">
        <p14:creationId xmlns:p14="http://schemas.microsoft.com/office/powerpoint/2010/main" val="3483205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0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21</cp:revision>
  <dcterms:created xsi:type="dcterms:W3CDTF">2022-05-10T05:11:22Z</dcterms:created>
  <dcterms:modified xsi:type="dcterms:W3CDTF">2022-05-11T09:29:38Z</dcterms:modified>
</cp:coreProperties>
</file>